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handoutMasterIdLst>
    <p:handoutMasterId r:id="rId7"/>
  </p:handoutMasterIdLst>
  <p:sldIdLst>
    <p:sldId id="372" r:id="rId2"/>
    <p:sldId id="376" r:id="rId3"/>
    <p:sldId id="378" r:id="rId4"/>
    <p:sldId id="369" r:id="rId5"/>
  </p:sldIdLst>
  <p:sldSz cx="10058400" cy="7772400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ECE"/>
    <a:srgbClr val="FF4242"/>
    <a:srgbClr val="FFAA35"/>
    <a:srgbClr val="00CC33"/>
    <a:srgbClr val="28D1FF"/>
    <a:srgbClr val="2C8C37"/>
    <a:srgbClr val="F32B2B"/>
    <a:srgbClr val="FFD700"/>
    <a:srgbClr val="FF9933"/>
    <a:srgbClr val="F714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157" autoAdjust="0"/>
    <p:restoredTop sz="95088" autoAdjust="0"/>
  </p:normalViewPr>
  <p:slideViewPr>
    <p:cSldViewPr snapToGrid="0">
      <p:cViewPr varScale="1">
        <p:scale>
          <a:sx n="109" d="100"/>
          <a:sy n="109" d="100"/>
        </p:scale>
        <p:origin x="1392" y="96"/>
      </p:cViewPr>
      <p:guideLst/>
    </p:cSldViewPr>
  </p:slideViewPr>
  <p:outlineViewPr>
    <p:cViewPr>
      <p:scale>
        <a:sx n="33" d="100"/>
        <a:sy n="33" d="100"/>
      </p:scale>
      <p:origin x="0" y="-1080"/>
    </p:cViewPr>
  </p:outlineViewPr>
  <p:notesTextViewPr>
    <p:cViewPr>
      <p:scale>
        <a:sx n="200" d="100"/>
        <a:sy n="200" d="100"/>
      </p:scale>
      <p:origin x="0" y="0"/>
    </p:cViewPr>
  </p:notesTextViewPr>
  <p:notesViewPr>
    <p:cSldViewPr snapToGrid="0" showGuides="1">
      <p:cViewPr varScale="1">
        <p:scale>
          <a:sx n="78" d="100"/>
          <a:sy n="78" d="100"/>
        </p:scale>
        <p:origin x="3132" y="96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82119" cy="466434"/>
          </a:xfrm>
          <a:prstGeom prst="rect">
            <a:avLst/>
          </a:prstGeom>
        </p:spPr>
        <p:txBody>
          <a:bodyPr vert="horz" lIns="93168" tIns="46584" rIns="93168" bIns="4658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98102" y="1"/>
            <a:ext cx="2982119" cy="466434"/>
          </a:xfrm>
          <a:prstGeom prst="rect">
            <a:avLst/>
          </a:prstGeom>
        </p:spPr>
        <p:txBody>
          <a:bodyPr vert="horz" lIns="93168" tIns="46584" rIns="93168" bIns="46584" rtlCol="0"/>
          <a:lstStyle>
            <a:lvl1pPr algn="r">
              <a:defRPr sz="1200"/>
            </a:lvl1pPr>
          </a:lstStyle>
          <a:p>
            <a:fld id="{B713BC32-36A2-47AF-A345-1906C01DD127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8829969"/>
            <a:ext cx="2982119" cy="466433"/>
          </a:xfrm>
          <a:prstGeom prst="rect">
            <a:avLst/>
          </a:prstGeom>
        </p:spPr>
        <p:txBody>
          <a:bodyPr vert="horz" lIns="93168" tIns="46584" rIns="93168" bIns="4658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98102" y="8829969"/>
            <a:ext cx="2982119" cy="466433"/>
          </a:xfrm>
          <a:prstGeom prst="rect">
            <a:avLst/>
          </a:prstGeom>
        </p:spPr>
        <p:txBody>
          <a:bodyPr vert="horz" lIns="93168" tIns="46584" rIns="93168" bIns="46584" rtlCol="0" anchor="b"/>
          <a:lstStyle>
            <a:lvl1pPr algn="r">
              <a:defRPr sz="1200"/>
            </a:lvl1pPr>
          </a:lstStyle>
          <a:p>
            <a:fld id="{D11AA3AE-020E-4F2E-8EEB-3E52FD2102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87748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82119" cy="466434"/>
          </a:xfrm>
          <a:prstGeom prst="rect">
            <a:avLst/>
          </a:prstGeom>
        </p:spPr>
        <p:txBody>
          <a:bodyPr vert="horz" lIns="93168" tIns="46584" rIns="93168" bIns="4658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1"/>
            <a:ext cx="2982119" cy="466434"/>
          </a:xfrm>
          <a:prstGeom prst="rect">
            <a:avLst/>
          </a:prstGeom>
        </p:spPr>
        <p:txBody>
          <a:bodyPr vert="horz" lIns="93168" tIns="46584" rIns="93168" bIns="46584" rtlCol="0"/>
          <a:lstStyle>
            <a:lvl1pPr algn="r">
              <a:defRPr sz="1200"/>
            </a:lvl1pPr>
          </a:lstStyle>
          <a:p>
            <a:fld id="{C4C81F7B-AADA-4513-B52A-171452DC446B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1288" y="1162050"/>
            <a:ext cx="4059237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8" tIns="46584" rIns="93168" bIns="4658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73892"/>
            <a:ext cx="5505450" cy="3660458"/>
          </a:xfrm>
          <a:prstGeom prst="rect">
            <a:avLst/>
          </a:prstGeom>
        </p:spPr>
        <p:txBody>
          <a:bodyPr vert="horz" lIns="93168" tIns="46584" rIns="93168" bIns="46584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9"/>
            <a:ext cx="2982119" cy="466433"/>
          </a:xfrm>
          <a:prstGeom prst="rect">
            <a:avLst/>
          </a:prstGeom>
        </p:spPr>
        <p:txBody>
          <a:bodyPr vert="horz" lIns="93168" tIns="46584" rIns="93168" bIns="4658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9"/>
            <a:ext cx="2982119" cy="466433"/>
          </a:xfrm>
          <a:prstGeom prst="rect">
            <a:avLst/>
          </a:prstGeom>
        </p:spPr>
        <p:txBody>
          <a:bodyPr vert="horz" lIns="93168" tIns="46584" rIns="93168" bIns="46584" rtlCol="0" anchor="b"/>
          <a:lstStyle>
            <a:lvl1pPr algn="r">
              <a:defRPr sz="1200"/>
            </a:lvl1pPr>
          </a:lstStyle>
          <a:p>
            <a:fld id="{EEEC78DE-7778-482C-A68D-FE1A7230EA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5777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11288" y="1162050"/>
            <a:ext cx="4059237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EEC78DE-7778-482C-A68D-FE1A7230EA9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2303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11288" y="1162050"/>
            <a:ext cx="4059237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EEC78DE-7778-482C-A68D-FE1A7230EA9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3672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0" y="1"/>
            <a:ext cx="10058400" cy="477078"/>
          </a:xfrm>
          <a:prstGeom prst="rect">
            <a:avLst/>
          </a:prstGeom>
        </p:spPr>
        <p:txBody>
          <a:bodyPr/>
          <a:lstStyle>
            <a:lvl1pPr algn="ctr"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5392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562583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4" r:id="rId1"/>
  </p:sldLayoutIdLst>
  <p:hf hdr="0"/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Nyala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0" y="7403068"/>
            <a:ext cx="14686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 Fig 1 </a:t>
            </a:r>
          </a:p>
        </p:txBody>
      </p:sp>
      <p:pic>
        <p:nvPicPr>
          <p:cNvPr id="5" name="Picture 4" descr="A graph of dna quality&#10;&#10;Description automatically generated">
            <a:extLst>
              <a:ext uri="{FF2B5EF4-FFF2-40B4-BE49-F238E27FC236}">
                <a16:creationId xmlns:a16="http://schemas.microsoft.com/office/drawing/2014/main" id="{A3471E68-469A-82B9-B6D6-5AA5B7E931C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4594" y="183806"/>
            <a:ext cx="6969211" cy="74047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65392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9C694B1-232D-D645-8B6B-D4B9AFBE9913}"/>
              </a:ext>
            </a:extLst>
          </p:cNvPr>
          <p:cNvSpPr txBox="1"/>
          <p:nvPr/>
        </p:nvSpPr>
        <p:spPr>
          <a:xfrm>
            <a:off x="1663700" y="699505"/>
            <a:ext cx="738997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ifferentially Expressed Genes (502)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85" r="6462"/>
          <a:stretch/>
        </p:blipFill>
        <p:spPr>
          <a:xfrm>
            <a:off x="4408349" y="1592510"/>
            <a:ext cx="5534626" cy="478366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7403068"/>
            <a:ext cx="14686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 Fig 2 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905" y="1592510"/>
            <a:ext cx="3860581" cy="377959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30385" y="1592510"/>
            <a:ext cx="347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813886" y="1592510"/>
            <a:ext cx="347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30721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-8182" y="7403068"/>
            <a:ext cx="3030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 Table 1</a:t>
            </a:r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-8182" y="0"/>
            <a:ext cx="3750188" cy="534572"/>
          </a:xfrm>
        </p:spPr>
        <p:txBody>
          <a:bodyPr/>
          <a:lstStyle/>
          <a:p>
            <a:r>
              <a:rPr lang="en-US" sz="2800" dirty="0"/>
              <a:t>Up Regulated Genes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3901443" y="0"/>
          <a:ext cx="6156957" cy="774213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9764">
                  <a:extLst>
                    <a:ext uri="{9D8B030D-6E8A-4147-A177-3AD203B41FA5}">
                      <a16:colId xmlns:a16="http://schemas.microsoft.com/office/drawing/2014/main" val="956646175"/>
                    </a:ext>
                  </a:extLst>
                </a:gridCol>
                <a:gridCol w="437550">
                  <a:extLst>
                    <a:ext uri="{9D8B030D-6E8A-4147-A177-3AD203B41FA5}">
                      <a16:colId xmlns:a16="http://schemas.microsoft.com/office/drawing/2014/main" val="4001866945"/>
                    </a:ext>
                  </a:extLst>
                </a:gridCol>
                <a:gridCol w="554751">
                  <a:extLst>
                    <a:ext uri="{9D8B030D-6E8A-4147-A177-3AD203B41FA5}">
                      <a16:colId xmlns:a16="http://schemas.microsoft.com/office/drawing/2014/main" val="4186607156"/>
                    </a:ext>
                  </a:extLst>
                </a:gridCol>
                <a:gridCol w="429737">
                  <a:extLst>
                    <a:ext uri="{9D8B030D-6E8A-4147-A177-3AD203B41FA5}">
                      <a16:colId xmlns:a16="http://schemas.microsoft.com/office/drawing/2014/main" val="1464983356"/>
                    </a:ext>
                  </a:extLst>
                </a:gridCol>
                <a:gridCol w="618536">
                  <a:extLst>
                    <a:ext uri="{9D8B030D-6E8A-4147-A177-3AD203B41FA5}">
                      <a16:colId xmlns:a16="http://schemas.microsoft.com/office/drawing/2014/main" val="243548163"/>
                    </a:ext>
                  </a:extLst>
                </a:gridCol>
                <a:gridCol w="464820">
                  <a:extLst>
                    <a:ext uri="{9D8B030D-6E8A-4147-A177-3AD203B41FA5}">
                      <a16:colId xmlns:a16="http://schemas.microsoft.com/office/drawing/2014/main" val="4091536264"/>
                    </a:ext>
                  </a:extLst>
                </a:gridCol>
                <a:gridCol w="1018449">
                  <a:extLst>
                    <a:ext uri="{9D8B030D-6E8A-4147-A177-3AD203B41FA5}">
                      <a16:colId xmlns:a16="http://schemas.microsoft.com/office/drawing/2014/main" val="9044416"/>
                    </a:ext>
                  </a:extLst>
                </a:gridCol>
                <a:gridCol w="398871">
                  <a:extLst>
                    <a:ext uri="{9D8B030D-6E8A-4147-A177-3AD203B41FA5}">
                      <a16:colId xmlns:a16="http://schemas.microsoft.com/office/drawing/2014/main" val="3189788871"/>
                    </a:ext>
                  </a:extLst>
                </a:gridCol>
                <a:gridCol w="1109115">
                  <a:extLst>
                    <a:ext uri="{9D8B030D-6E8A-4147-A177-3AD203B41FA5}">
                      <a16:colId xmlns:a16="http://schemas.microsoft.com/office/drawing/2014/main" val="704719823"/>
                    </a:ext>
                  </a:extLst>
                </a:gridCol>
                <a:gridCol w="445364">
                  <a:extLst>
                    <a:ext uri="{9D8B030D-6E8A-4147-A177-3AD203B41FA5}">
                      <a16:colId xmlns:a16="http://schemas.microsoft.com/office/drawing/2014/main" val="1322186608"/>
                    </a:ext>
                  </a:extLst>
                </a:gridCol>
              </a:tblGrid>
              <a:tr h="107445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 to microRNA-1-3p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 to microRNA-22-3p</a:t>
                      </a: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 to microRNA-30c-5p</a:t>
                      </a: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 to microRNA-122-5p</a:t>
                      </a: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 to microRNA-133a-3p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6615653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 2 FC</a:t>
                      </a: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 2 FC</a:t>
                      </a: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 2 FC</a:t>
                      </a: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 2 FC</a:t>
                      </a: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 2 FC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5512492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OL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F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S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2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A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7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NGB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8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6286078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F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P16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5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F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R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lane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2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2965209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6AP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ZI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R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1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R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B561A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070521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MBI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8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RS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R2L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5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KBH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DX4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8855919"/>
                  </a:ext>
                </a:extLst>
              </a:tr>
              <a:tr h="1084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yc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4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BP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kbh6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4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GS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5371259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5orf6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8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BXO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XM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3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F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2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64631654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F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1f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EDC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5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RAI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G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9888816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AP4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3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F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DX4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CA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6P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2009212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NE8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7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ct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7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2AK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4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K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bp1l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7451938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F2R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4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0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OVL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BAR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ct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8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2964430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EDC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IG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8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KD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8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NN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IG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0588153"/>
                  </a:ext>
                </a:extLst>
              </a:tr>
              <a:tr h="1084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DX4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4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TD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4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O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2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LD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3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m17b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4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3750042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H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2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RC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4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GS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RC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9479661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G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O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3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2AC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0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OVL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AR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2007607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KD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RBI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OVL6 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4588859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O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6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M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7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XIM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5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KD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PS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9317967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830045P16Rik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1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F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0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ct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0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ZR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3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M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4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6559253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BXO34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8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AZ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8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7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LNT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4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T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4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8580627"/>
                  </a:ext>
                </a:extLst>
              </a:tr>
              <a:tr h="1084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X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2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X11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U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_H4-K20_MeTrfa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1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LF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8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2991026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ct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3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AT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1R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3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ct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M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3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1888439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4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4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PP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0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LHL2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IG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IN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0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8350511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IG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5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MT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LHL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6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GN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MD10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2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5607309"/>
                  </a:ext>
                </a:extLst>
              </a:tr>
              <a:tr h="1084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GN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IL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m17b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A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0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DH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9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2142855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LHL29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6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LID3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CAT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4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MS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F10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9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8023635"/>
                  </a:ext>
                </a:extLst>
              </a:tr>
              <a:tr h="1084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YAT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4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MD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P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1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m17b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l1d1l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2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945433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S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wwp2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0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RC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CAT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9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24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9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022833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4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l1d1l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3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K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7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B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PTIN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9143599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O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9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PH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9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7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25A3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7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1273961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M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4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TC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OX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-Atp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P6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3988700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MCE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9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24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M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9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CB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2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P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8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8774436"/>
                  </a:ext>
                </a:extLst>
              </a:tr>
              <a:tr h="108460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GFD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2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25A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MD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E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membrane protein 258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7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2294570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X11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25A3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XO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6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MCE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4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PS37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9554338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MD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C2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RD1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3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AZ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DR4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0983424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RRES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R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4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24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LAF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HIT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2626847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DH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3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BP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8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25A3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0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GF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9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0129932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XO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8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PL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1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sf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X11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4307720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OBTB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4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pin/Tipinl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BP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7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N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011140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OT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P2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8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P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3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M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8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8013753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F11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W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7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BC1D9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AS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476878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F21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3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HIT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5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NT5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IN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4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2301357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PH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0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IF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7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A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3551416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TC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LL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9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AF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0153871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PTIN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8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C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LID3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3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0537348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25A3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8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em2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MD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0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6189523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7A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47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9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F21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2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037212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PL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5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W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GDI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287815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P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9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FD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T2D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4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4476926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PT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PS37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25A3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2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5004214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NT5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DR4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8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IM10L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8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1607272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IF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DR54 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8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AP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8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2345472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W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1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P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5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070989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BE2D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BC1D1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7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1767140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DR4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3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d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2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2518894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DR54 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IF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4764275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pin/Tipinl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1492500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ED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9585845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em2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7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7349201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PPC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827874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3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3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7930409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XNDC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9177523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BALD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4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6515030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BE2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8378573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FD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7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5529734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MP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3463948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PS37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5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0295711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DR4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6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9771642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DR5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4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2761881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DHHC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6390644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F6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9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7980972"/>
                  </a:ext>
                </a:extLst>
              </a:tr>
              <a:tr h="107445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NHIT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69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320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43584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608796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-8182" y="7403068"/>
            <a:ext cx="3030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 Table 2</a:t>
            </a:r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3154106" y="1079500"/>
            <a:ext cx="3750188" cy="534572"/>
          </a:xfrm>
        </p:spPr>
        <p:txBody>
          <a:bodyPr/>
          <a:lstStyle/>
          <a:p>
            <a:r>
              <a:rPr lang="en-US" sz="2800" dirty="0"/>
              <a:t>Search Terms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8CFC49D-351D-36A4-237D-F1CEC14FC9D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1459777"/>
              </p:ext>
            </p:extLst>
          </p:nvPr>
        </p:nvGraphicFramePr>
        <p:xfrm>
          <a:off x="3699061" y="1732508"/>
          <a:ext cx="2660278" cy="493236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2660278">
                  <a:extLst>
                    <a:ext uri="{9D8B030D-6E8A-4147-A177-3AD203B41FA5}">
                      <a16:colId xmlns:a16="http://schemas.microsoft.com/office/drawing/2014/main" val="82005815"/>
                    </a:ext>
                  </a:extLst>
                </a:gridCol>
              </a:tblGrid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ogenes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317251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as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8631205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p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0925022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7092512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iu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9707515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tilag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6380846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differen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9419111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divisio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2973609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ondr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4693023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s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7741659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6396394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ch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1306298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wth pla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9381978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wth zo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7002740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pk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9216692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senchy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0437292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f</a:t>
                      </a: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et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0230679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forming growth facto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4269261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sif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5374794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te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6723387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kele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9653201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sicl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7922210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amin 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0470655"/>
                  </a:ext>
                </a:extLst>
              </a:tr>
              <a:tr h="205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n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63" marR="8563" marT="85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17613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126976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307</TotalTime>
  <Words>600</Words>
  <Application>Microsoft Office PowerPoint</Application>
  <PresentationFormat>Custom</PresentationFormat>
  <Paragraphs>546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Nyala</vt:lpstr>
      <vt:lpstr>Office Theme</vt:lpstr>
      <vt:lpstr>PowerPoint Presentation</vt:lpstr>
      <vt:lpstr>PowerPoint Presentation</vt:lpstr>
      <vt:lpstr>Up Regulated Genes</vt:lpstr>
      <vt:lpstr>Search Terms</vt:lpstr>
    </vt:vector>
  </TitlesOfParts>
  <Company>VC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gress Update</dc:title>
  <dc:creator>Niels Asmussen</dc:creator>
  <cp:lastModifiedBy>David Cohen</cp:lastModifiedBy>
  <cp:revision>567</cp:revision>
  <cp:lastPrinted>2022-06-07T20:06:53Z</cp:lastPrinted>
  <dcterms:created xsi:type="dcterms:W3CDTF">2017-01-12T16:02:09Z</dcterms:created>
  <dcterms:modified xsi:type="dcterms:W3CDTF">2023-12-21T20:46:59Z</dcterms:modified>
</cp:coreProperties>
</file>